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90360" y="767880"/>
            <a:ext cx="5118120" cy="3837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  <a:defRPr b="0" lang="it-IT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C31EF6AC-5E04-45E2-B206-BA8BBBD41CB7}" type="slidenum">
              <a:rPr b="0" lang="it-IT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29753671-65E2-45F4-B9B5-7EC20FD979CC}" type="slidenum">
              <a:rPr b="0" lang="it-IT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E93BD-C135-4EEF-98E8-67FFCD3B20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CA8EE-967B-4D82-8E20-FA36444156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509F4-F8F2-43B1-8DFA-8AE3A2D4D2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076A8-D080-40C4-AD19-D8BEED5BC1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DA820-2AB1-4E67-9470-0C59395E45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7EBC9-7754-4685-8726-801993EA81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E7798-194B-4DF0-BACA-9DEEF7B5C3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70A4A-015A-491A-85B6-2F500FF8E6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0165D-12CE-46AC-A413-77295BE0C3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1267A-0B3D-4635-A5F2-8E74F73BDF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77A16-0F8D-4E65-834D-E18356380A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1BA89-9830-4274-8974-64CEFD3007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0F7B4A-EB06-44F0-9F1D-A136E9035ADF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0"/>
          <p:cNvSpPr/>
          <p:nvPr/>
        </p:nvSpPr>
        <p:spPr>
          <a:xfrm>
            <a:off x="214200" y="344520"/>
            <a:ext cx="85726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Supplementary  Fig. 1: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of immunoreactive CR-1 in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affin-embedded, formalin-fixed tissues. (A) and (B): Clark II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imary human melanoma;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 and (D): Clark III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imary human melanoma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and (C): control IgG; (B) and (D): anti-CR-1 antibod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2"/>
          <p:cNvSpPr/>
          <p:nvPr/>
        </p:nvSpPr>
        <p:spPr>
          <a:xfrm>
            <a:off x="839880" y="1268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4"/>
          <p:cNvSpPr/>
          <p:nvPr/>
        </p:nvSpPr>
        <p:spPr>
          <a:xfrm>
            <a:off x="828720" y="3925800"/>
            <a:ext cx="35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Immagine 5" descr="CLII_IgG_20X.tif"/>
          <p:cNvPicPr/>
          <p:nvPr/>
        </p:nvPicPr>
        <p:blipFill>
          <a:blip r:embed="rId1"/>
          <a:stretch/>
        </p:blipFill>
        <p:spPr>
          <a:xfrm>
            <a:off x="1332000" y="1413000"/>
            <a:ext cx="2743200" cy="2057400"/>
          </a:xfrm>
          <a:prstGeom prst="rect">
            <a:avLst/>
          </a:prstGeom>
          <a:ln w="0">
            <a:noFill/>
          </a:ln>
        </p:spPr>
      </p:pic>
      <p:pic>
        <p:nvPicPr>
          <p:cNvPr id="52" name="Immagine 6" descr="CLII_CR_20X.tif"/>
          <p:cNvPicPr/>
          <p:nvPr/>
        </p:nvPicPr>
        <p:blipFill>
          <a:blip r:embed="rId2"/>
          <a:stretch/>
        </p:blipFill>
        <p:spPr>
          <a:xfrm>
            <a:off x="4932360" y="1413000"/>
            <a:ext cx="2743200" cy="2057400"/>
          </a:xfrm>
          <a:prstGeom prst="rect">
            <a:avLst/>
          </a:prstGeom>
          <a:ln w="0">
            <a:noFill/>
          </a:ln>
        </p:spPr>
      </p:pic>
      <p:pic>
        <p:nvPicPr>
          <p:cNvPr id="53" name="Immagine 7" descr="CLIII_IgG_20X.tif"/>
          <p:cNvPicPr/>
          <p:nvPr/>
        </p:nvPicPr>
        <p:blipFill>
          <a:blip r:embed="rId3"/>
          <a:stretch/>
        </p:blipFill>
        <p:spPr>
          <a:xfrm>
            <a:off x="1258920" y="4005360"/>
            <a:ext cx="2743200" cy="2057400"/>
          </a:xfrm>
          <a:prstGeom prst="rect">
            <a:avLst/>
          </a:prstGeom>
          <a:ln w="0">
            <a:noFill/>
          </a:ln>
        </p:spPr>
      </p:pic>
      <p:pic>
        <p:nvPicPr>
          <p:cNvPr id="54" name="Immagine 8" descr="CLIII_CR_20Xbis.tif"/>
          <p:cNvPicPr/>
          <p:nvPr/>
        </p:nvPicPr>
        <p:blipFill>
          <a:blip r:embed="rId4"/>
          <a:stretch/>
        </p:blipFill>
        <p:spPr>
          <a:xfrm>
            <a:off x="4932360" y="4005360"/>
            <a:ext cx="2743200" cy="205740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12"/>
          <p:cNvSpPr/>
          <p:nvPr/>
        </p:nvSpPr>
        <p:spPr>
          <a:xfrm>
            <a:off x="4591080" y="1268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4"/>
          <p:cNvSpPr/>
          <p:nvPr/>
        </p:nvSpPr>
        <p:spPr>
          <a:xfrm>
            <a:off x="4573440" y="392580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02T09:17:09Z</dcterms:created>
  <dc:creator>Antonella</dc:creator>
  <dc:description/>
  <dc:language>en-US</dc:language>
  <cp:lastModifiedBy>j.jagadheesh</cp:lastModifiedBy>
  <dcterms:modified xsi:type="dcterms:W3CDTF">2011-08-11T15:26:55Z</dcterms:modified>
  <cp:revision>178</cp:revision>
  <dc:subject/>
  <dc:title>Diapositiva 1</dc:title>
</cp:coreProperties>
</file>